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C7A8081-8AB5-430A-A0EF-41E525A6EB94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5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6EF1020-650E-4857-A2B4-24A63504561A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3C16F7-8496-403A-9B2D-22CF96925EF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66370B-2E0B-4668-999A-316CB893DAF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79870D-D464-461A-ADBD-DC8B722F638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82AF82-0BAF-4F52-A27C-95EF5BA236E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65F1CC-3DA8-422B-B167-6A53D775D56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599EB9-FA34-4CF7-A9C0-4B086D864BD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4939FC-B5B0-4F23-A16C-16A931E6888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AD8B2C-9764-457E-8F41-F95D576C057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36CBAD-CC01-47C5-8797-FFF30A154D4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E67062-18FB-4394-B84F-FEEEA62DF06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50A922-9272-4686-8F7B-1D368690E44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C94256-3ED1-4125-927B-98E57214D3E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DD9D20C-78E0-4D19-8470-6598A305852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3" descr=""/>
          <p:cNvPicPr/>
          <p:nvPr/>
        </p:nvPicPr>
        <p:blipFill>
          <a:blip r:embed="rId1"/>
          <a:stretch/>
        </p:blipFill>
        <p:spPr>
          <a:xfrm>
            <a:off x="379440" y="1752480"/>
            <a:ext cx="6097680" cy="7086600"/>
          </a:xfrm>
          <a:prstGeom prst="rect">
            <a:avLst/>
          </a:prstGeom>
          <a:ln w="0">
            <a:noFill/>
          </a:ln>
        </p:spPr>
      </p:pic>
      <p:sp>
        <p:nvSpPr>
          <p:cNvPr id="49" name=""/>
          <p:cNvSpPr/>
          <p:nvPr/>
        </p:nvSpPr>
        <p:spPr>
          <a:xfrm>
            <a:off x="380520" y="338040"/>
            <a:ext cx="6284520" cy="1342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dditional File 3 Bin-mapping the wheat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LKR/SDH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gene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ST BE606591 was bin-mapped to the long arm of wheat chromosomes 6A and 6B by Randhawa et al. [29]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he original Southern blot was provided by K.S. Gill (personal communication). BE606591 was labeled and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ybridized to DNA from an aneuploid series of wheat cultivar Chinese Spring and lines missing segments of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pecific chromosomes. As examples: 6BL5 is missing a segment of the long arm of chromosome 6B from a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reakpoint through the telomere; N6BT6A is nullisomic for chromosome 6B and tetrasomic for chromosome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A; DT6AS is ditelosomic for the short arm of chromosome 6A. Red boxes mark the lines most relevant to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in-mapping the LKR/SDH genes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04T19:54:01Z</dcterms:created>
  <dc:creator> </dc:creator>
  <dc:description/>
  <dc:language>en-US</dc:language>
  <cp:lastModifiedBy>Office 2003 Registered User</cp:lastModifiedBy>
  <dcterms:modified xsi:type="dcterms:W3CDTF">2010-05-18T22:34:31Z</dcterms:modified>
  <cp:revision>2</cp:revision>
  <dc:subject/>
  <dc:title>Slide 1</dc:title>
</cp:coreProperties>
</file>